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72" r:id="rId12"/>
    <p:sldId id="273" r:id="rId13"/>
    <p:sldId id="274" r:id="rId14"/>
    <p:sldId id="270" r:id="rId15"/>
    <p:sldId id="275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DD90EC5-3C4A-47FB-9DE8-7812C5281E7D}" v="4" dt="2022-10-19T14:52:01.44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754" y="8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24" Type="http://schemas.microsoft.com/office/2015/10/relationships/revisionInfo" Target="revisionInfo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microsoft.com/office/2016/11/relationships/changesInfo" Target="changesInfos/changesInfo1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eil Bodagh" userId="e52d4dae24034bea" providerId="LiveId" clId="{5435FADB-4278-44B7-8452-4EDBA663EC24}"/>
    <pc:docChg chg="undo custSel modSld">
      <pc:chgData name="Neil Bodagh" userId="e52d4dae24034bea" providerId="LiveId" clId="{5435FADB-4278-44B7-8452-4EDBA663EC24}" dt="2022-08-06T05:52:36.830" v="179" actId="123"/>
      <pc:docMkLst>
        <pc:docMk/>
      </pc:docMkLst>
      <pc:sldChg chg="modSp mod">
        <pc:chgData name="Neil Bodagh" userId="e52d4dae24034bea" providerId="LiveId" clId="{5435FADB-4278-44B7-8452-4EDBA663EC24}" dt="2022-07-28T17:28:13.919" v="68" actId="113"/>
        <pc:sldMkLst>
          <pc:docMk/>
          <pc:sldMk cId="1089892516" sldId="260"/>
        </pc:sldMkLst>
        <pc:spChg chg="mod">
          <ac:chgData name="Neil Bodagh" userId="e52d4dae24034bea" providerId="LiveId" clId="{5435FADB-4278-44B7-8452-4EDBA663EC24}" dt="2022-07-28T17:28:13.919" v="68" actId="113"/>
          <ac:spMkLst>
            <pc:docMk/>
            <pc:sldMk cId="1089892516" sldId="260"/>
            <ac:spMk id="3" creationId="{00000000-0000-0000-0000-000000000000}"/>
          </ac:spMkLst>
        </pc:spChg>
      </pc:sldChg>
      <pc:sldChg chg="modSp mod">
        <pc:chgData name="Neil Bodagh" userId="e52d4dae24034bea" providerId="LiveId" clId="{5435FADB-4278-44B7-8452-4EDBA663EC24}" dt="2022-07-29T07:41:21.219" v="69" actId="123"/>
        <pc:sldMkLst>
          <pc:docMk/>
          <pc:sldMk cId="2079782646" sldId="262"/>
        </pc:sldMkLst>
        <pc:spChg chg="mod">
          <ac:chgData name="Neil Bodagh" userId="e52d4dae24034bea" providerId="LiveId" clId="{5435FADB-4278-44B7-8452-4EDBA663EC24}" dt="2022-07-29T07:41:21.219" v="69" actId="123"/>
          <ac:spMkLst>
            <pc:docMk/>
            <pc:sldMk cId="2079782646" sldId="262"/>
            <ac:spMk id="7" creationId="{B8D3B6C7-0380-989A-4C1F-9DD7E4F61F33}"/>
          </ac:spMkLst>
        </pc:spChg>
      </pc:sldChg>
      <pc:sldChg chg="modSp mod">
        <pc:chgData name="Neil Bodagh" userId="e52d4dae24034bea" providerId="LiveId" clId="{5435FADB-4278-44B7-8452-4EDBA663EC24}" dt="2022-07-29T07:41:27.465" v="70" actId="123"/>
        <pc:sldMkLst>
          <pc:docMk/>
          <pc:sldMk cId="2883334632" sldId="263"/>
        </pc:sldMkLst>
        <pc:spChg chg="mod">
          <ac:chgData name="Neil Bodagh" userId="e52d4dae24034bea" providerId="LiveId" clId="{5435FADB-4278-44B7-8452-4EDBA663EC24}" dt="2022-07-29T07:41:27.465" v="70" actId="123"/>
          <ac:spMkLst>
            <pc:docMk/>
            <pc:sldMk cId="2883334632" sldId="263"/>
            <ac:spMk id="5" creationId="{00000000-0000-0000-0000-000000000000}"/>
          </ac:spMkLst>
        </pc:spChg>
      </pc:sldChg>
      <pc:sldChg chg="modSp mod">
        <pc:chgData name="Neil Bodagh" userId="e52d4dae24034bea" providerId="LiveId" clId="{5435FADB-4278-44B7-8452-4EDBA663EC24}" dt="2022-07-28T17:24:43.526" v="16" actId="552"/>
        <pc:sldMkLst>
          <pc:docMk/>
          <pc:sldMk cId="149728198" sldId="264"/>
        </pc:sldMkLst>
        <pc:spChg chg="mod">
          <ac:chgData name="Neil Bodagh" userId="e52d4dae24034bea" providerId="LiveId" clId="{5435FADB-4278-44B7-8452-4EDBA663EC24}" dt="2022-07-28T17:24:43.526" v="16" actId="552"/>
          <ac:spMkLst>
            <pc:docMk/>
            <pc:sldMk cId="149728198" sldId="264"/>
            <ac:spMk id="5" creationId="{00000000-0000-0000-0000-000000000000}"/>
          </ac:spMkLst>
        </pc:spChg>
        <pc:spChg chg="mod">
          <ac:chgData name="Neil Bodagh" userId="e52d4dae24034bea" providerId="LiveId" clId="{5435FADB-4278-44B7-8452-4EDBA663EC24}" dt="2022-07-28T17:24:43.526" v="16" actId="552"/>
          <ac:spMkLst>
            <pc:docMk/>
            <pc:sldMk cId="149728198" sldId="264"/>
            <ac:spMk id="13" creationId="{0D73D564-2E14-E8B0-AB81-A2A33D60DB75}"/>
          </ac:spMkLst>
        </pc:spChg>
        <pc:spChg chg="mod">
          <ac:chgData name="Neil Bodagh" userId="e52d4dae24034bea" providerId="LiveId" clId="{5435FADB-4278-44B7-8452-4EDBA663EC24}" dt="2022-07-28T17:24:00.503" v="14" actId="207"/>
          <ac:spMkLst>
            <pc:docMk/>
            <pc:sldMk cId="149728198" sldId="264"/>
            <ac:spMk id="14" creationId="{2D15B4BB-6E15-8361-0585-DB520B8F5A02}"/>
          </ac:spMkLst>
        </pc:spChg>
      </pc:sldChg>
      <pc:sldChg chg="modSp mod">
        <pc:chgData name="Neil Bodagh" userId="e52d4dae24034bea" providerId="LiveId" clId="{5435FADB-4278-44B7-8452-4EDBA663EC24}" dt="2022-07-29T07:41:59.541" v="71" actId="123"/>
        <pc:sldMkLst>
          <pc:docMk/>
          <pc:sldMk cId="2946818097" sldId="265"/>
        </pc:sldMkLst>
        <pc:spChg chg="mod">
          <ac:chgData name="Neil Bodagh" userId="e52d4dae24034bea" providerId="LiveId" clId="{5435FADB-4278-44B7-8452-4EDBA663EC24}" dt="2022-07-29T07:41:59.541" v="71" actId="123"/>
          <ac:spMkLst>
            <pc:docMk/>
            <pc:sldMk cId="2946818097" sldId="265"/>
            <ac:spMk id="5" creationId="{00000000-0000-0000-0000-000000000000}"/>
          </ac:spMkLst>
        </pc:spChg>
        <pc:spChg chg="mod">
          <ac:chgData name="Neil Bodagh" userId="e52d4dae24034bea" providerId="LiveId" clId="{5435FADB-4278-44B7-8452-4EDBA663EC24}" dt="2022-07-28T17:24:53.390" v="17" actId="207"/>
          <ac:spMkLst>
            <pc:docMk/>
            <pc:sldMk cId="2946818097" sldId="265"/>
            <ac:spMk id="8" creationId="{867E4754-B38A-C306-2CE9-21951FFC83D0}"/>
          </ac:spMkLst>
        </pc:spChg>
      </pc:sldChg>
      <pc:sldChg chg="modSp mod">
        <pc:chgData name="Neil Bodagh" userId="e52d4dae24034bea" providerId="LiveId" clId="{5435FADB-4278-44B7-8452-4EDBA663EC24}" dt="2022-07-28T17:27:54.663" v="66" actId="123"/>
        <pc:sldMkLst>
          <pc:docMk/>
          <pc:sldMk cId="1470050889" sldId="269"/>
        </pc:sldMkLst>
        <pc:spChg chg="mod">
          <ac:chgData name="Neil Bodagh" userId="e52d4dae24034bea" providerId="LiveId" clId="{5435FADB-4278-44B7-8452-4EDBA663EC24}" dt="2022-07-28T17:27:54.663" v="66" actId="123"/>
          <ac:spMkLst>
            <pc:docMk/>
            <pc:sldMk cId="1470050889" sldId="269"/>
            <ac:spMk id="6" creationId="{00000000-0000-0000-0000-000000000000}"/>
          </ac:spMkLst>
        </pc:spChg>
      </pc:sldChg>
      <pc:sldChg chg="modSp mod">
        <pc:chgData name="Neil Bodagh" userId="e52d4dae24034bea" providerId="LiveId" clId="{5435FADB-4278-44B7-8452-4EDBA663EC24}" dt="2022-08-06T05:52:36.830" v="179" actId="123"/>
        <pc:sldMkLst>
          <pc:docMk/>
          <pc:sldMk cId="2298962906" sldId="270"/>
        </pc:sldMkLst>
        <pc:spChg chg="mod">
          <ac:chgData name="Neil Bodagh" userId="e52d4dae24034bea" providerId="LiveId" clId="{5435FADB-4278-44B7-8452-4EDBA663EC24}" dt="2022-08-06T05:52:36.830" v="179" actId="123"/>
          <ac:spMkLst>
            <pc:docMk/>
            <pc:sldMk cId="2298962906" sldId="270"/>
            <ac:spMk id="5" creationId="{00000000-0000-0000-0000-000000000000}"/>
          </ac:spMkLst>
        </pc:spChg>
      </pc:sldChg>
      <pc:sldChg chg="modSp mod">
        <pc:chgData name="Neil Bodagh" userId="e52d4dae24034bea" providerId="LiveId" clId="{5435FADB-4278-44B7-8452-4EDBA663EC24}" dt="2022-07-29T07:42:24.259" v="73" actId="123"/>
        <pc:sldMkLst>
          <pc:docMk/>
          <pc:sldMk cId="316174652" sldId="271"/>
        </pc:sldMkLst>
        <pc:spChg chg="mod">
          <ac:chgData name="Neil Bodagh" userId="e52d4dae24034bea" providerId="LiveId" clId="{5435FADB-4278-44B7-8452-4EDBA663EC24}" dt="2022-07-29T07:42:24.259" v="73" actId="123"/>
          <ac:spMkLst>
            <pc:docMk/>
            <pc:sldMk cId="316174652" sldId="271"/>
            <ac:spMk id="5" creationId="{00000000-0000-0000-0000-000000000000}"/>
          </ac:spMkLst>
        </pc:spChg>
        <pc:spChg chg="mod">
          <ac:chgData name="Neil Bodagh" userId="e52d4dae24034bea" providerId="LiveId" clId="{5435FADB-4278-44B7-8452-4EDBA663EC24}" dt="2022-07-28T17:25:34.221" v="24" actId="207"/>
          <ac:spMkLst>
            <pc:docMk/>
            <pc:sldMk cId="316174652" sldId="271"/>
            <ac:spMk id="11" creationId="{1D73AB0A-92FB-70C1-7447-860275ECD987}"/>
          </ac:spMkLst>
        </pc:spChg>
        <pc:spChg chg="mod">
          <ac:chgData name="Neil Bodagh" userId="e52d4dae24034bea" providerId="LiveId" clId="{5435FADB-4278-44B7-8452-4EDBA663EC24}" dt="2022-07-28T17:25:38.212" v="25" actId="207"/>
          <ac:spMkLst>
            <pc:docMk/>
            <pc:sldMk cId="316174652" sldId="271"/>
            <ac:spMk id="12" creationId="{A399265C-47AC-D2EE-794C-CAA0B1B55F57}"/>
          </ac:spMkLst>
        </pc:spChg>
      </pc:sldChg>
      <pc:sldChg chg="modSp mod">
        <pc:chgData name="Neil Bodagh" userId="e52d4dae24034bea" providerId="LiveId" clId="{5435FADB-4278-44B7-8452-4EDBA663EC24}" dt="2022-07-29T07:43:23.222" v="117" actId="20577"/>
        <pc:sldMkLst>
          <pc:docMk/>
          <pc:sldMk cId="782830419" sldId="272"/>
        </pc:sldMkLst>
        <pc:spChg chg="mod">
          <ac:chgData name="Neil Bodagh" userId="e52d4dae24034bea" providerId="LiveId" clId="{5435FADB-4278-44B7-8452-4EDBA663EC24}" dt="2022-07-29T07:43:23.222" v="117" actId="20577"/>
          <ac:spMkLst>
            <pc:docMk/>
            <pc:sldMk cId="782830419" sldId="272"/>
            <ac:spMk id="7" creationId="{B8D3B6C7-0380-989A-4C1F-9DD7E4F61F33}"/>
          </ac:spMkLst>
        </pc:spChg>
      </pc:sldChg>
      <pc:sldChg chg="modSp mod">
        <pc:chgData name="Neil Bodagh" userId="e52d4dae24034bea" providerId="LiveId" clId="{5435FADB-4278-44B7-8452-4EDBA663EC24}" dt="2022-07-29T07:44:09.952" v="158" actId="20577"/>
        <pc:sldMkLst>
          <pc:docMk/>
          <pc:sldMk cId="4290905043" sldId="273"/>
        </pc:sldMkLst>
        <pc:spChg chg="mod">
          <ac:chgData name="Neil Bodagh" userId="e52d4dae24034bea" providerId="LiveId" clId="{5435FADB-4278-44B7-8452-4EDBA663EC24}" dt="2022-07-29T07:44:09.952" v="158" actId="20577"/>
          <ac:spMkLst>
            <pc:docMk/>
            <pc:sldMk cId="4290905043" sldId="273"/>
            <ac:spMk id="7" creationId="{B8D3B6C7-0380-989A-4C1F-9DD7E4F61F33}"/>
          </ac:spMkLst>
        </pc:spChg>
      </pc:sldChg>
    </pc:docChg>
  </pc:docChgLst>
  <pc:docChgLst>
    <pc:chgData name="Neil Bodagh" userId="e52d4dae24034bea" providerId="LiveId" clId="{CDD90EC5-3C4A-47FB-9DE8-7812C5281E7D}"/>
    <pc:docChg chg="undo custSel addSld delSld modSld">
      <pc:chgData name="Neil Bodagh" userId="e52d4dae24034bea" providerId="LiveId" clId="{CDD90EC5-3C4A-47FB-9DE8-7812C5281E7D}" dt="2022-10-24T09:05:59.295" v="176" actId="20577"/>
      <pc:docMkLst>
        <pc:docMk/>
      </pc:docMkLst>
      <pc:sldChg chg="modSp mod">
        <pc:chgData name="Neil Bodagh" userId="e52d4dae24034bea" providerId="LiveId" clId="{CDD90EC5-3C4A-47FB-9DE8-7812C5281E7D}" dt="2022-10-24T09:01:21.296" v="175" actId="20577"/>
        <pc:sldMkLst>
          <pc:docMk/>
          <pc:sldMk cId="1089892516" sldId="260"/>
        </pc:sldMkLst>
        <pc:spChg chg="mod">
          <ac:chgData name="Neil Bodagh" userId="e52d4dae24034bea" providerId="LiveId" clId="{CDD90EC5-3C4A-47FB-9DE8-7812C5281E7D}" dt="2022-10-24T09:01:21.296" v="175" actId="20577"/>
          <ac:spMkLst>
            <pc:docMk/>
            <pc:sldMk cId="1089892516" sldId="260"/>
            <ac:spMk id="2" creationId="{00000000-0000-0000-0000-000000000000}"/>
          </ac:spMkLst>
        </pc:spChg>
        <pc:spChg chg="mod">
          <ac:chgData name="Neil Bodagh" userId="e52d4dae24034bea" providerId="LiveId" clId="{CDD90EC5-3C4A-47FB-9DE8-7812C5281E7D}" dt="2022-10-19T14:57:02.452" v="170" actId="20577"/>
          <ac:spMkLst>
            <pc:docMk/>
            <pc:sldMk cId="1089892516" sldId="260"/>
            <ac:spMk id="4" creationId="{00000000-0000-0000-0000-000000000000}"/>
          </ac:spMkLst>
        </pc:spChg>
      </pc:sldChg>
      <pc:sldChg chg="modSp mod">
        <pc:chgData name="Neil Bodagh" userId="e52d4dae24034bea" providerId="LiveId" clId="{CDD90EC5-3C4A-47FB-9DE8-7812C5281E7D}" dt="2022-10-19T14:54:42.915" v="162" actId="20577"/>
        <pc:sldMkLst>
          <pc:docMk/>
          <pc:sldMk cId="149728198" sldId="264"/>
        </pc:sldMkLst>
        <pc:spChg chg="mod">
          <ac:chgData name="Neil Bodagh" userId="e52d4dae24034bea" providerId="LiveId" clId="{CDD90EC5-3C4A-47FB-9DE8-7812C5281E7D}" dt="2022-10-19T13:08:01.476" v="34" actId="255"/>
          <ac:spMkLst>
            <pc:docMk/>
            <pc:sldMk cId="149728198" sldId="264"/>
            <ac:spMk id="5" creationId="{00000000-0000-0000-0000-000000000000}"/>
          </ac:spMkLst>
        </pc:spChg>
        <pc:spChg chg="mod">
          <ac:chgData name="Neil Bodagh" userId="e52d4dae24034bea" providerId="LiveId" clId="{CDD90EC5-3C4A-47FB-9DE8-7812C5281E7D}" dt="2022-10-19T13:08:08.145" v="35" actId="255"/>
          <ac:spMkLst>
            <pc:docMk/>
            <pc:sldMk cId="149728198" sldId="264"/>
            <ac:spMk id="13" creationId="{0D73D564-2E14-E8B0-AB81-A2A33D60DB75}"/>
          </ac:spMkLst>
        </pc:spChg>
        <pc:spChg chg="mod">
          <ac:chgData name="Neil Bodagh" userId="e52d4dae24034bea" providerId="LiveId" clId="{CDD90EC5-3C4A-47FB-9DE8-7812C5281E7D}" dt="2022-10-19T14:54:42.915" v="162" actId="20577"/>
          <ac:spMkLst>
            <pc:docMk/>
            <pc:sldMk cId="149728198" sldId="264"/>
            <ac:spMk id="14" creationId="{2D15B4BB-6E15-8361-0585-DB520B8F5A02}"/>
          </ac:spMkLst>
        </pc:spChg>
      </pc:sldChg>
      <pc:sldChg chg="modSp mod">
        <pc:chgData name="Neil Bodagh" userId="e52d4dae24034bea" providerId="LiveId" clId="{CDD90EC5-3C4A-47FB-9DE8-7812C5281E7D}" dt="2022-10-19T13:08:14.356" v="36" actId="255"/>
        <pc:sldMkLst>
          <pc:docMk/>
          <pc:sldMk cId="2946818097" sldId="265"/>
        </pc:sldMkLst>
        <pc:spChg chg="mod">
          <ac:chgData name="Neil Bodagh" userId="e52d4dae24034bea" providerId="LiveId" clId="{CDD90EC5-3C4A-47FB-9DE8-7812C5281E7D}" dt="2022-10-19T13:08:14.356" v="36" actId="255"/>
          <ac:spMkLst>
            <pc:docMk/>
            <pc:sldMk cId="2946818097" sldId="265"/>
            <ac:spMk id="5" creationId="{00000000-0000-0000-0000-000000000000}"/>
          </ac:spMkLst>
        </pc:spChg>
      </pc:sldChg>
      <pc:sldChg chg="modSp del mod setBg">
        <pc:chgData name="Neil Bodagh" userId="e52d4dae24034bea" providerId="LiveId" clId="{CDD90EC5-3C4A-47FB-9DE8-7812C5281E7D}" dt="2022-10-19T13:20:29.919" v="104" actId="2696"/>
        <pc:sldMkLst>
          <pc:docMk/>
          <pc:sldMk cId="1470050889" sldId="269"/>
        </pc:sldMkLst>
        <pc:spChg chg="mod">
          <ac:chgData name="Neil Bodagh" userId="e52d4dae24034bea" providerId="LiveId" clId="{CDD90EC5-3C4A-47FB-9DE8-7812C5281E7D}" dt="2022-10-19T13:16:12.348" v="66" actId="27636"/>
          <ac:spMkLst>
            <pc:docMk/>
            <pc:sldMk cId="1470050889" sldId="269"/>
            <ac:spMk id="5" creationId="{00000000-0000-0000-0000-000000000000}"/>
          </ac:spMkLst>
        </pc:spChg>
        <pc:spChg chg="mod">
          <ac:chgData name="Neil Bodagh" userId="e52d4dae24034bea" providerId="LiveId" clId="{CDD90EC5-3C4A-47FB-9DE8-7812C5281E7D}" dt="2022-10-19T13:17:24.784" v="77" actId="20577"/>
          <ac:spMkLst>
            <pc:docMk/>
            <pc:sldMk cId="1470050889" sldId="269"/>
            <ac:spMk id="6" creationId="{00000000-0000-0000-0000-000000000000}"/>
          </ac:spMkLst>
        </pc:spChg>
        <pc:spChg chg="mod">
          <ac:chgData name="Neil Bodagh" userId="e52d4dae24034bea" providerId="LiveId" clId="{CDD90EC5-3C4A-47FB-9DE8-7812C5281E7D}" dt="2022-10-19T13:17:32.083" v="79" actId="1076"/>
          <ac:spMkLst>
            <pc:docMk/>
            <pc:sldMk cId="1470050889" sldId="269"/>
            <ac:spMk id="7" creationId="{00000000-0000-0000-0000-000000000000}"/>
          </ac:spMkLst>
        </pc:spChg>
        <pc:picChg chg="mod">
          <ac:chgData name="Neil Bodagh" userId="e52d4dae24034bea" providerId="LiveId" clId="{CDD90EC5-3C4A-47FB-9DE8-7812C5281E7D}" dt="2022-10-19T13:16:39.842" v="70" actId="1076"/>
          <ac:picMkLst>
            <pc:docMk/>
            <pc:sldMk cId="1470050889" sldId="269"/>
            <ac:picMk id="11" creationId="{2887453F-C9F6-54CB-16CC-72BB8644CF24}"/>
          </ac:picMkLst>
        </pc:picChg>
        <pc:picChg chg="mod">
          <ac:chgData name="Neil Bodagh" userId="e52d4dae24034bea" providerId="LiveId" clId="{CDD90EC5-3C4A-47FB-9DE8-7812C5281E7D}" dt="2022-10-19T13:15:54.434" v="59" actId="1076"/>
          <ac:picMkLst>
            <pc:docMk/>
            <pc:sldMk cId="1470050889" sldId="269"/>
            <ac:picMk id="12" creationId="{76E19CEE-3D6B-F124-D38E-CD51C5E07DDE}"/>
          </ac:picMkLst>
        </pc:picChg>
        <pc:picChg chg="mod">
          <ac:chgData name="Neil Bodagh" userId="e52d4dae24034bea" providerId="LiveId" clId="{CDD90EC5-3C4A-47FB-9DE8-7812C5281E7D}" dt="2022-10-19T13:17:27.338" v="78" actId="1076"/>
          <ac:picMkLst>
            <pc:docMk/>
            <pc:sldMk cId="1470050889" sldId="269"/>
            <ac:picMk id="13" creationId="{D53BFCBD-B4BF-4949-B5BA-B8DA20FE0065}"/>
          </ac:picMkLst>
        </pc:picChg>
      </pc:sldChg>
      <pc:sldChg chg="modSp mod">
        <pc:chgData name="Neil Bodagh" userId="e52d4dae24034bea" providerId="LiveId" clId="{CDD90EC5-3C4A-47FB-9DE8-7812C5281E7D}" dt="2022-10-19T14:56:51.406" v="163" actId="14100"/>
        <pc:sldMkLst>
          <pc:docMk/>
          <pc:sldMk cId="2298962906" sldId="270"/>
        </pc:sldMkLst>
        <pc:spChg chg="mod">
          <ac:chgData name="Neil Bodagh" userId="e52d4dae24034bea" providerId="LiveId" clId="{CDD90EC5-3C4A-47FB-9DE8-7812C5281E7D}" dt="2022-10-19T14:56:51.406" v="163" actId="14100"/>
          <ac:spMkLst>
            <pc:docMk/>
            <pc:sldMk cId="2298962906" sldId="270"/>
            <ac:spMk id="5" creationId="{00000000-0000-0000-0000-000000000000}"/>
          </ac:spMkLst>
        </pc:spChg>
      </pc:sldChg>
      <pc:sldChg chg="addSp modSp mod">
        <pc:chgData name="Neil Bodagh" userId="e52d4dae24034bea" providerId="LiveId" clId="{CDD90EC5-3C4A-47FB-9DE8-7812C5281E7D}" dt="2022-10-19T14:57:35.738" v="173" actId="554"/>
        <pc:sldMkLst>
          <pc:docMk/>
          <pc:sldMk cId="316174652" sldId="271"/>
        </pc:sldMkLst>
        <pc:spChg chg="mod">
          <ac:chgData name="Neil Bodagh" userId="e52d4dae24034bea" providerId="LiveId" clId="{CDD90EC5-3C4A-47FB-9DE8-7812C5281E7D}" dt="2022-10-19T14:53:18.292" v="140" actId="1076"/>
          <ac:spMkLst>
            <pc:docMk/>
            <pc:sldMk cId="316174652" sldId="271"/>
            <ac:spMk id="2" creationId="{00000000-0000-0000-0000-000000000000}"/>
          </ac:spMkLst>
        </pc:spChg>
        <pc:spChg chg="mod">
          <ac:chgData name="Neil Bodagh" userId="e52d4dae24034bea" providerId="LiveId" clId="{CDD90EC5-3C4A-47FB-9DE8-7812C5281E7D}" dt="2022-10-19T14:53:12.229" v="138" actId="14100"/>
          <ac:spMkLst>
            <pc:docMk/>
            <pc:sldMk cId="316174652" sldId="271"/>
            <ac:spMk id="5" creationId="{00000000-0000-0000-0000-000000000000}"/>
          </ac:spMkLst>
        </pc:spChg>
        <pc:spChg chg="add mod">
          <ac:chgData name="Neil Bodagh" userId="e52d4dae24034bea" providerId="LiveId" clId="{CDD90EC5-3C4A-47FB-9DE8-7812C5281E7D}" dt="2022-10-19T14:52:01.443" v="130" actId="571"/>
          <ac:spMkLst>
            <pc:docMk/>
            <pc:sldMk cId="316174652" sldId="271"/>
            <ac:spMk id="6" creationId="{02B8E9BA-4F8C-78A2-BD92-FD159CBD3B66}"/>
          </ac:spMkLst>
        </pc:spChg>
        <pc:spChg chg="add mod">
          <ac:chgData name="Neil Bodagh" userId="e52d4dae24034bea" providerId="LiveId" clId="{CDD90EC5-3C4A-47FB-9DE8-7812C5281E7D}" dt="2022-10-19T14:52:01.443" v="130" actId="571"/>
          <ac:spMkLst>
            <pc:docMk/>
            <pc:sldMk cId="316174652" sldId="271"/>
            <ac:spMk id="7" creationId="{9AC59A56-E7DA-3E83-FBAB-DE535AD91D99}"/>
          </ac:spMkLst>
        </pc:spChg>
        <pc:spChg chg="mod">
          <ac:chgData name="Neil Bodagh" userId="e52d4dae24034bea" providerId="LiveId" clId="{CDD90EC5-3C4A-47FB-9DE8-7812C5281E7D}" dt="2022-10-19T14:57:35.738" v="173" actId="554"/>
          <ac:spMkLst>
            <pc:docMk/>
            <pc:sldMk cId="316174652" sldId="271"/>
            <ac:spMk id="11" creationId="{1D73AB0A-92FB-70C1-7447-860275ECD987}"/>
          </ac:spMkLst>
        </pc:spChg>
        <pc:spChg chg="mod">
          <ac:chgData name="Neil Bodagh" userId="e52d4dae24034bea" providerId="LiveId" clId="{CDD90EC5-3C4A-47FB-9DE8-7812C5281E7D}" dt="2022-10-19T14:57:35.738" v="173" actId="554"/>
          <ac:spMkLst>
            <pc:docMk/>
            <pc:sldMk cId="316174652" sldId="271"/>
            <ac:spMk id="12" creationId="{A399265C-47AC-D2EE-794C-CAA0B1B55F57}"/>
          </ac:spMkLst>
        </pc:spChg>
        <pc:picChg chg="mod">
          <ac:chgData name="Neil Bodagh" userId="e52d4dae24034bea" providerId="LiveId" clId="{CDD90EC5-3C4A-47FB-9DE8-7812C5281E7D}" dt="2022-10-19T14:52:14.724" v="133" actId="1076"/>
          <ac:picMkLst>
            <pc:docMk/>
            <pc:sldMk cId="316174652" sldId="271"/>
            <ac:picMk id="8" creationId="{D7AAA588-EA4C-B526-8E80-8D7DDB64D4F8}"/>
          </ac:picMkLst>
        </pc:picChg>
        <pc:picChg chg="mod">
          <ac:chgData name="Neil Bodagh" userId="e52d4dae24034bea" providerId="LiveId" clId="{CDD90EC5-3C4A-47FB-9DE8-7812C5281E7D}" dt="2022-10-19T14:52:19.996" v="134" actId="1076"/>
          <ac:picMkLst>
            <pc:docMk/>
            <pc:sldMk cId="316174652" sldId="271"/>
            <ac:picMk id="10" creationId="{D5760A64-E6D3-4647-77A6-6CE26C11D6CD}"/>
          </ac:picMkLst>
        </pc:picChg>
      </pc:sldChg>
      <pc:sldChg chg="modSp mod">
        <pc:chgData name="Neil Bodagh" userId="e52d4dae24034bea" providerId="LiveId" clId="{CDD90EC5-3C4A-47FB-9DE8-7812C5281E7D}" dt="2022-10-19T13:09:07.196" v="51" actId="14100"/>
        <pc:sldMkLst>
          <pc:docMk/>
          <pc:sldMk cId="4290905043" sldId="273"/>
        </pc:sldMkLst>
        <pc:spChg chg="mod">
          <ac:chgData name="Neil Bodagh" userId="e52d4dae24034bea" providerId="LiveId" clId="{CDD90EC5-3C4A-47FB-9DE8-7812C5281E7D}" dt="2022-10-19T13:09:07.196" v="51" actId="14100"/>
          <ac:spMkLst>
            <pc:docMk/>
            <pc:sldMk cId="4290905043" sldId="273"/>
            <ac:spMk id="7" creationId="{B8D3B6C7-0380-989A-4C1F-9DD7E4F61F33}"/>
          </ac:spMkLst>
        </pc:spChg>
      </pc:sldChg>
      <pc:sldChg chg="modSp add mod">
        <pc:chgData name="Neil Bodagh" userId="e52d4dae24034bea" providerId="LiveId" clId="{CDD90EC5-3C4A-47FB-9DE8-7812C5281E7D}" dt="2022-10-24T09:05:59.295" v="176" actId="20577"/>
        <pc:sldMkLst>
          <pc:docMk/>
          <pc:sldMk cId="4207921127" sldId="274"/>
        </pc:sldMkLst>
        <pc:spChg chg="mod">
          <ac:chgData name="Neil Bodagh" userId="e52d4dae24034bea" providerId="LiveId" clId="{CDD90EC5-3C4A-47FB-9DE8-7812C5281E7D}" dt="2022-10-19T13:17:53.651" v="95" actId="20577"/>
          <ac:spMkLst>
            <pc:docMk/>
            <pc:sldMk cId="4207921127" sldId="274"/>
            <ac:spMk id="2" creationId="{00000000-0000-0000-0000-000000000000}"/>
          </ac:spMkLst>
        </pc:spChg>
        <pc:spChg chg="mod">
          <ac:chgData name="Neil Bodagh" userId="e52d4dae24034bea" providerId="LiveId" clId="{CDD90EC5-3C4A-47FB-9DE8-7812C5281E7D}" dt="2022-10-24T09:05:59.295" v="176" actId="20577"/>
          <ac:spMkLst>
            <pc:docMk/>
            <pc:sldMk cId="4207921127" sldId="274"/>
            <ac:spMk id="7" creationId="{B8D3B6C7-0380-989A-4C1F-9DD7E4F61F33}"/>
          </ac:spMkLst>
        </pc:spChg>
      </pc:sldChg>
      <pc:sldChg chg="modSp add mod">
        <pc:chgData name="Neil Bodagh" userId="e52d4dae24034bea" providerId="LiveId" clId="{CDD90EC5-3C4A-47FB-9DE8-7812C5281E7D}" dt="2022-10-19T13:22:16.477" v="112" actId="6549"/>
        <pc:sldMkLst>
          <pc:docMk/>
          <pc:sldMk cId="1516800325" sldId="275"/>
        </pc:sldMkLst>
        <pc:spChg chg="mod">
          <ac:chgData name="Neil Bodagh" userId="e52d4dae24034bea" providerId="LiveId" clId="{CDD90EC5-3C4A-47FB-9DE8-7812C5281E7D}" dt="2022-10-19T13:22:16.477" v="112" actId="6549"/>
          <ac:spMkLst>
            <pc:docMk/>
            <pc:sldMk cId="1516800325" sldId="275"/>
            <ac:spMk id="5" creationId="{00000000-0000-0000-0000-000000000000}"/>
          </ac:spMkLst>
        </pc:spChg>
      </pc:sldChg>
      <pc:sldChg chg="new del">
        <pc:chgData name="Neil Bodagh" userId="e52d4dae24034bea" providerId="LiveId" clId="{CDD90EC5-3C4A-47FB-9DE8-7812C5281E7D}" dt="2022-10-19T14:27:42.189" v="114" actId="680"/>
        <pc:sldMkLst>
          <pc:docMk/>
          <pc:sldMk cId="265364544" sldId="276"/>
        </pc:sldMkLst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4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4/10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1250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713128"/>
            <a:ext cx="6120680" cy="360040"/>
          </a:xfrm>
        </p:spPr>
        <p:txBody>
          <a:bodyPr>
            <a:normAutofit fontScale="90000"/>
          </a:bodyPr>
          <a:lstStyle/>
          <a:p>
            <a:r>
              <a:rPr lang="en-GB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ynchronous atrio-ventricular sequential pacing utilising conventional and leadless pacemakers in an elderly patient: a case report</a:t>
            </a: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40497" y="4142538"/>
            <a:ext cx="6119812" cy="360363"/>
          </a:xfrm>
        </p:spPr>
        <p:txBody>
          <a:bodyPr/>
          <a:lstStyle/>
          <a:p>
            <a:r>
              <a:rPr lang="en-GB" dirty="0"/>
              <a:t>October 2022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64332" y="892969"/>
            <a:ext cx="7729538" cy="3534750"/>
          </a:xfrm>
        </p:spPr>
        <p:txBody>
          <a:bodyPr>
            <a:noAutofit/>
          </a:bodyPr>
          <a:lstStyle/>
          <a:p>
            <a:pPr algn="just"/>
            <a:r>
              <a:rPr lang="en-GB" b="0" dirty="0">
                <a:solidFill>
                  <a:srgbClr val="C00000"/>
                </a:solidFill>
                <a:latin typeface="+mj-lt"/>
              </a:rPr>
              <a:t>[1]</a:t>
            </a:r>
            <a:r>
              <a:rPr lang="en-GB" b="0" dirty="0">
                <a:solidFill>
                  <a:srgbClr val="C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Reddy VY, Knops RE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Sperzel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J, Miller MA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Petru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J, Simon J et al. Permanent leadless cardiac pacing: Results of the LEADLESS trial. </a:t>
            </a:r>
            <a:r>
              <a:rPr lang="en-GB" b="0" i="1" dirty="0">
                <a:effectLst/>
                <a:latin typeface="+mj-lt"/>
                <a:ea typeface="Times New Roman" panose="02020603050405020304" pitchFamily="18" charset="0"/>
              </a:rPr>
              <a:t>Circulation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2014;129:1466–1471. </a:t>
            </a:r>
          </a:p>
          <a:p>
            <a:pPr algn="just"/>
            <a:r>
              <a:rPr lang="en-GB" b="0" dirty="0">
                <a:solidFill>
                  <a:srgbClr val="C00000"/>
                </a:solidFill>
                <a:latin typeface="+mj-lt"/>
                <a:cs typeface="Times New Roman" panose="02020603050405020304" pitchFamily="18" charset="0"/>
              </a:rPr>
              <a:t>[2]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Steinwender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C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Khelae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SK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Garweg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C, Chan JYS, Ritter P, Johansen JB et al. Atrioventricular Synchronous Pacing Using a Leadless Ventricular Pacemaker: Results From the MARVEL 2 Study. </a:t>
            </a:r>
            <a:r>
              <a:rPr lang="en-GB" b="0" i="1" dirty="0">
                <a:effectLst/>
                <a:latin typeface="+mj-lt"/>
                <a:ea typeface="Times New Roman" panose="02020603050405020304" pitchFamily="18" charset="0"/>
              </a:rPr>
              <a:t>JACC: Clinical Electrophysiology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2020;6:94–106. </a:t>
            </a:r>
          </a:p>
          <a:p>
            <a:pPr algn="just"/>
            <a:r>
              <a:rPr lang="en-GB" b="0" dirty="0">
                <a:solidFill>
                  <a:srgbClr val="C00000"/>
                </a:solidFill>
                <a:latin typeface="+mj-lt"/>
                <a:cs typeface="Times New Roman" panose="02020603050405020304" pitchFamily="18" charset="0"/>
              </a:rPr>
              <a:t>[3] 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Nicosia A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Iacopino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S, Nigro G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Zucchelli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G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Tomasi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L, D’Agostino C et al. Performance of transcatheter pacing system use in relation to patients’ age. </a:t>
            </a:r>
            <a:r>
              <a:rPr lang="en-GB" b="0" i="1" dirty="0">
                <a:effectLst/>
                <a:latin typeface="+mj-lt"/>
                <a:ea typeface="Times New Roman" panose="02020603050405020304" pitchFamily="18" charset="0"/>
              </a:rPr>
              <a:t>Journal of Interventional Cardiac Electrophysiology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2022. </a:t>
            </a:r>
            <a:endParaRPr lang="en-GB" b="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64332" y="785813"/>
            <a:ext cx="7729538" cy="3641906"/>
          </a:xfrm>
        </p:spPr>
        <p:txBody>
          <a:bodyPr>
            <a:noAutofit/>
          </a:bodyPr>
          <a:lstStyle/>
          <a:p>
            <a:pPr algn="just"/>
            <a:r>
              <a:rPr lang="en-GB" b="0" dirty="0">
                <a:solidFill>
                  <a:srgbClr val="C00000"/>
                </a:solidFill>
                <a:latin typeface="+mj-lt"/>
                <a:cs typeface="Times New Roman" panose="02020603050405020304" pitchFamily="18" charset="0"/>
              </a:rPr>
              <a:t>[4]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Arps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K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Piccini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JP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Yapejian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R, 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Leguire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R, Smith B, Al-Khatib SM et al. Optimizing mechanically sensed atrial tracking in patients with atrioventricular-synchronous leadless pacemakers: A single-</a:t>
            </a:r>
            <a:r>
              <a:rPr lang="en-GB" b="0" dirty="0" err="1">
                <a:effectLst/>
                <a:latin typeface="+mj-lt"/>
                <a:ea typeface="Times New Roman" panose="02020603050405020304" pitchFamily="18" charset="0"/>
              </a:rPr>
              <a:t>center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experience. </a:t>
            </a:r>
            <a:r>
              <a:rPr lang="en-GB" b="0" i="1" dirty="0">
                <a:effectLst/>
                <a:latin typeface="+mj-lt"/>
                <a:ea typeface="Times New Roman" panose="02020603050405020304" pitchFamily="18" charset="0"/>
              </a:rPr>
              <a:t>Heart Rhythm O2</a:t>
            </a:r>
            <a:r>
              <a:rPr lang="en-GB" b="0" dirty="0">
                <a:effectLst/>
                <a:latin typeface="+mj-lt"/>
                <a:ea typeface="Times New Roman" panose="02020603050405020304" pitchFamily="18" charset="0"/>
              </a:rPr>
              <a:t> 2021;2:455–462. </a:t>
            </a:r>
            <a:endParaRPr lang="en-GB" b="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516800325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7" name="Content Placeholder 4">
            <a:extLst>
              <a:ext uri="{FF2B5EF4-FFF2-40B4-BE49-F238E27FC236}">
                <a16:creationId xmlns:a16="http://schemas.microsoft.com/office/drawing/2014/main" id="{B8D3B6C7-0380-989A-4C1F-9DD7E4F61F33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702640" y="871538"/>
            <a:ext cx="7264689" cy="3378702"/>
          </a:xfrm>
        </p:spPr>
        <p:txBody>
          <a:bodyPr>
            <a:normAutofit/>
          </a:bodyPr>
          <a:lstStyle/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Leadless pacemakers may avert complications associated with transvenous devices related to the generator and leads.[1]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Atrio-ventricular synchrony can be achieved with leadless devices through accelerometer-based atrial sensing.[2]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In elderly patients who encounter ventricular lead failures with transvenous pacemakers, this option may avoid the need for lead extraction and lead-based device re-implantation.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Presenting complai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b="0" dirty="0">
                <a:effectLst/>
                <a:latin typeface="+mj-lt"/>
                <a:ea typeface="Calibri" panose="020F0502020204030204" pitchFamily="34" charset="0"/>
              </a:rPr>
              <a:t>90 year-old-male presented with new onset intermittent dizziness. </a:t>
            </a:r>
          </a:p>
          <a:p>
            <a:pPr algn="just"/>
            <a:r>
              <a:rPr lang="en-GB" b="0" dirty="0">
                <a:effectLst/>
                <a:latin typeface="+mj-lt"/>
                <a:ea typeface="Calibri" panose="020F0502020204030204" pitchFamily="34" charset="0"/>
              </a:rPr>
              <a:t>Previous history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b="0" dirty="0">
                <a:latin typeface="+mj-lt"/>
                <a:ea typeface="Calibri" panose="020F0502020204030204" pitchFamily="34" charset="0"/>
              </a:rPr>
              <a:t>P</a:t>
            </a:r>
            <a:r>
              <a:rPr lang="en-GB" b="0" dirty="0">
                <a:effectLst/>
                <a:latin typeface="+mj-lt"/>
                <a:ea typeface="Calibri" panose="020F0502020204030204" pitchFamily="34" charset="0"/>
              </a:rPr>
              <a:t>revious left-sided dual-chamber pacemaker inserted for complete heart block 8 years prior. Complicated by insulation failure and increased noise detection from both the ventricular and atrial leads with inhibition of pacing.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b="0" dirty="0">
                <a:effectLst/>
                <a:latin typeface="+mj-lt"/>
                <a:ea typeface="Calibri" panose="020F0502020204030204" pitchFamily="34" charset="0"/>
              </a:rPr>
              <a:t>Right-sided dual chamber pacemaker subsequently implanted. Left-sided box explanted and leads buried. </a:t>
            </a:r>
            <a:endParaRPr lang="en-GB" b="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6996343" cy="729208"/>
          </a:xfrm>
        </p:spPr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b="0" dirty="0">
                <a:effectLst/>
                <a:latin typeface="+mj-lt"/>
                <a:ea typeface="Calibri" panose="020F0502020204030204" pitchFamily="34" charset="0"/>
              </a:rPr>
              <a:t>The electrocardiogram rhythm strip demonstrated complete heart block (figure 1).</a:t>
            </a:r>
            <a:endParaRPr lang="en-GB" b="0" dirty="0">
              <a:latin typeface="+mj-lt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14F6EFEB-A5E3-B08A-DDFB-012DA840EB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9815" y="2101769"/>
            <a:ext cx="5727994" cy="641383"/>
          </a:xfrm>
          <a:prstGeom prst="rect">
            <a:avLst/>
          </a:prstGeom>
        </p:spPr>
      </p:pic>
      <p:sp>
        <p:nvSpPr>
          <p:cNvPr id="13" name="Content Placeholder 4">
            <a:extLst>
              <a:ext uri="{FF2B5EF4-FFF2-40B4-BE49-F238E27FC236}">
                <a16:creationId xmlns:a16="http://schemas.microsoft.com/office/drawing/2014/main" id="{0D73D564-2E14-E8B0-AB81-A2A33D60DB75}"/>
              </a:ext>
            </a:extLst>
          </p:cNvPr>
          <p:cNvSpPr txBox="1">
            <a:spLocks/>
          </p:cNvSpPr>
          <p:nvPr/>
        </p:nvSpPr>
        <p:spPr>
          <a:xfrm>
            <a:off x="971999" y="3762461"/>
            <a:ext cx="6996343" cy="729208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85750" indent="-285750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GB" b="0" dirty="0">
                <a:latin typeface="+mj-lt"/>
              </a:rPr>
              <a:t>P</a:t>
            </a:r>
            <a:r>
              <a:rPr lang="en-GB" b="0" dirty="0">
                <a:effectLst/>
                <a:latin typeface="+mj-lt"/>
              </a:rPr>
              <a:t>acing check revealed right ventricular lead failure with loss of right ventricular capture.</a:t>
            </a:r>
          </a:p>
        </p:txBody>
      </p:sp>
      <p:sp>
        <p:nvSpPr>
          <p:cNvPr id="14" name="Content Placeholder 4">
            <a:extLst>
              <a:ext uri="{FF2B5EF4-FFF2-40B4-BE49-F238E27FC236}">
                <a16:creationId xmlns:a16="http://schemas.microsoft.com/office/drawing/2014/main" id="{2D15B4BB-6E15-8361-0585-DB520B8F5A02}"/>
              </a:ext>
            </a:extLst>
          </p:cNvPr>
          <p:cNvSpPr txBox="1">
            <a:spLocks/>
          </p:cNvSpPr>
          <p:nvPr/>
        </p:nvSpPr>
        <p:spPr>
          <a:xfrm>
            <a:off x="1581600" y="2771863"/>
            <a:ext cx="5712170" cy="729208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20000"/>
              </a:lnSpc>
            </a:pPr>
            <a:r>
              <a:rPr lang="en-GB" sz="1800" b="0" dirty="0">
                <a:solidFill>
                  <a:srgbClr val="C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gure 1. </a:t>
            </a:r>
            <a:r>
              <a:rPr lang="en-GB" sz="1800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ectrocardiogram rhythm strip exhibiting complete heart block.</a:t>
            </a: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</p:spPr>
        <p:txBody>
          <a:bodyPr anchor="ctr">
            <a:normAutofit/>
          </a:bodyPr>
          <a:lstStyle/>
          <a:p>
            <a:r>
              <a:rPr lang="en-GB" b="0"/>
              <a:t>Case Presentation</a:t>
            </a:r>
            <a:br>
              <a:rPr lang="en-GB" b="0"/>
            </a:br>
            <a:r>
              <a:rPr lang="en-GB" b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 anchor="ctr">
            <a:normAutofit/>
          </a:bodyPr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 anchor="ctr">
            <a:normAutofit/>
          </a:bodyPr>
          <a:lstStyle/>
          <a:p>
            <a:pPr>
              <a:spcAft>
                <a:spcPts val="600"/>
              </a:spcAft>
            </a:pPr>
            <a:fld id="{20C15474-9A8A-469E-9DC0-A1D69AB524A6}" type="slidenum">
              <a:rPr lang="en-GB" smtClean="0"/>
              <a:pPr>
                <a:spcAft>
                  <a:spcPts val="600"/>
                </a:spcAft>
              </a:pPr>
              <a:t>5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>
            <a:noAutofit/>
          </a:bodyPr>
          <a:lstStyle/>
          <a:p>
            <a:pPr marL="285750" indent="-285750" algn="just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GB" b="0" dirty="0">
                <a:effectLst/>
              </a:rPr>
              <a:t>Urgent temporary pacing wire inserted through the right femoral vein. </a:t>
            </a:r>
          </a:p>
          <a:p>
            <a:pPr marL="285750" indent="-285750" algn="just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GB" b="0" dirty="0">
                <a:effectLst/>
              </a:rPr>
              <a:t>Temporary externalised VVIR pacemaker implanted. The femoral temporary wire was removed (figure 2).</a:t>
            </a:r>
          </a:p>
          <a:p>
            <a:pPr marL="285750" indent="-285750" algn="just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GB" b="0" dirty="0"/>
              <a:t>Permanent device options were discussed in a multidisciplinary team meeting.</a:t>
            </a:r>
            <a:endParaRPr lang="en-GB" b="0" dirty="0">
              <a:effectLst/>
            </a:endParaRPr>
          </a:p>
        </p:txBody>
      </p:sp>
      <p:pic>
        <p:nvPicPr>
          <p:cNvPr id="7" name="Picture 6" descr="A picture containing x-ray film, head covering, blur&#10;&#10;Description automatically generated">
            <a:extLst>
              <a:ext uri="{FF2B5EF4-FFF2-40B4-BE49-F238E27FC236}">
                <a16:creationId xmlns:a16="http://schemas.microsoft.com/office/drawing/2014/main" id="{0D1D0831-8186-0686-F364-10F61C43B8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2" r="6794"/>
          <a:stretch/>
        </p:blipFill>
        <p:spPr>
          <a:xfrm>
            <a:off x="4708873" y="816805"/>
            <a:ext cx="2990321" cy="2740783"/>
          </a:xfrm>
          <a:prstGeom prst="rect">
            <a:avLst/>
          </a:prstGeom>
          <a:noFill/>
        </p:spPr>
      </p:pic>
      <p:sp>
        <p:nvSpPr>
          <p:cNvPr id="8" name="Content Placeholder 4">
            <a:extLst>
              <a:ext uri="{FF2B5EF4-FFF2-40B4-BE49-F238E27FC236}">
                <a16:creationId xmlns:a16="http://schemas.microsoft.com/office/drawing/2014/main" id="{867E4754-B38A-C306-2CE9-21951FFC83D0}"/>
              </a:ext>
            </a:extLst>
          </p:cNvPr>
          <p:cNvSpPr txBox="1">
            <a:spLocks/>
          </p:cNvSpPr>
          <p:nvPr/>
        </p:nvSpPr>
        <p:spPr>
          <a:xfrm>
            <a:off x="4689132" y="3626682"/>
            <a:ext cx="3026118" cy="881025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90000"/>
              </a:lnSpc>
            </a:pPr>
            <a:r>
              <a:rPr lang="en-GB" sz="1000" b="0" dirty="0">
                <a:solidFill>
                  <a:srgbClr val="C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gure 2. </a:t>
            </a:r>
            <a:r>
              <a:rPr lang="en-GB" sz="1000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hest X-ray following external pacemaker implantation demonstrating the presence of five right sided leads (two leads from the left-sided device, two leads from the right-sided device and one lead from the external pacemaker).</a:t>
            </a:r>
          </a:p>
          <a:p>
            <a:pPr marL="285750" indent="-285750" algn="just">
              <a:lnSpc>
                <a:spcPct val="90000"/>
              </a:lnSpc>
              <a:buFont typeface="Arial" panose="020B0604020202020204" pitchFamily="34" charset="0"/>
              <a:buChar char="•"/>
            </a:pPr>
            <a:endParaRPr lang="en-GB" sz="1000" b="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4456" y="184944"/>
            <a:ext cx="6552728" cy="857250"/>
          </a:xfrm>
        </p:spPr>
        <p:txBody>
          <a:bodyPr anchor="ctr">
            <a:normAutofit/>
          </a:bodyPr>
          <a:lstStyle/>
          <a:p>
            <a:r>
              <a:rPr lang="en-GB" b="0" dirty="0"/>
              <a:t>Case Presentation</a:t>
            </a:r>
            <a:br>
              <a:rPr lang="en-GB" b="0" dirty="0"/>
            </a:br>
            <a:r>
              <a:rPr lang="en-GB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 anchor="ctr">
            <a:normAutofit/>
          </a:bodyPr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7504" y="4803998"/>
            <a:ext cx="432048" cy="274637"/>
          </a:xfrm>
        </p:spPr>
        <p:txBody>
          <a:bodyPr anchor="ctr">
            <a:normAutofit/>
          </a:bodyPr>
          <a:lstStyle/>
          <a:p>
            <a:pPr>
              <a:spcAft>
                <a:spcPts val="600"/>
              </a:spcAft>
            </a:pPr>
            <a:fld id="{20C15474-9A8A-469E-9DC0-A1D69AB524A6}" type="slidenum">
              <a:rPr lang="en-GB" smtClean="0"/>
              <a:pPr>
                <a:spcAft>
                  <a:spcPts val="600"/>
                </a:spcAft>
              </a:pPr>
              <a:t>6</a:t>
            </a:fld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85800" y="1028700"/>
            <a:ext cx="7908131" cy="3278980"/>
          </a:xfrm>
        </p:spPr>
        <p:txBody>
          <a:bodyPr>
            <a:normAutofit/>
          </a:bodyPr>
          <a:lstStyle/>
          <a:p>
            <a:pPr marL="285750" indent="-285750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GB" b="0" dirty="0">
                <a:effectLst/>
              </a:rPr>
              <a:t>Micra atrio-ventricular leadless pacemaker implanted (figure 3). </a:t>
            </a:r>
          </a:p>
          <a:p>
            <a:pPr marL="285750" indent="-285750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GB" b="0" dirty="0">
                <a:effectLst/>
              </a:rPr>
              <a:t>Device tracked the atrial rhythm at 60bpm (AAIR pacing from the right sided device) (figure 4).</a:t>
            </a:r>
          </a:p>
        </p:txBody>
      </p:sp>
      <p:pic>
        <p:nvPicPr>
          <p:cNvPr id="8" name="Picture 7" descr="A picture containing timeline&#10;&#10;Description automatically generated">
            <a:extLst>
              <a:ext uri="{FF2B5EF4-FFF2-40B4-BE49-F238E27FC236}">
                <a16:creationId xmlns:a16="http://schemas.microsoft.com/office/drawing/2014/main" id="{D7AAA588-EA4C-B526-8E80-8D7DDB64D4F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9181" y="1954512"/>
            <a:ext cx="3105671" cy="1920714"/>
          </a:xfrm>
          <a:prstGeom prst="rect">
            <a:avLst/>
          </a:prstGeom>
        </p:spPr>
      </p:pic>
      <p:pic>
        <p:nvPicPr>
          <p:cNvPr id="10" name="Picture 9" descr="A picture containing text&#10;&#10;Description automatically generated">
            <a:extLst>
              <a:ext uri="{FF2B5EF4-FFF2-40B4-BE49-F238E27FC236}">
                <a16:creationId xmlns:a16="http://schemas.microsoft.com/office/drawing/2014/main" id="{D5760A64-E6D3-4647-77A6-6CE26C11D6C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4056" y="1947367"/>
            <a:ext cx="2133506" cy="1949012"/>
          </a:xfrm>
          <a:prstGeom prst="rect">
            <a:avLst/>
          </a:prstGeom>
        </p:spPr>
      </p:pic>
      <p:sp>
        <p:nvSpPr>
          <p:cNvPr id="11" name="Content Placeholder 4">
            <a:extLst>
              <a:ext uri="{FF2B5EF4-FFF2-40B4-BE49-F238E27FC236}">
                <a16:creationId xmlns:a16="http://schemas.microsoft.com/office/drawing/2014/main" id="{1D73AB0A-92FB-70C1-7447-860275ECD987}"/>
              </a:ext>
            </a:extLst>
          </p:cNvPr>
          <p:cNvSpPr txBox="1">
            <a:spLocks/>
          </p:cNvSpPr>
          <p:nvPr/>
        </p:nvSpPr>
        <p:spPr>
          <a:xfrm>
            <a:off x="1207293" y="3914816"/>
            <a:ext cx="2157413" cy="809585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0" dirty="0">
                <a:solidFill>
                  <a:srgbClr val="C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gure 3. </a:t>
            </a:r>
            <a:r>
              <a:rPr lang="en-GB" sz="1000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luoroscopic view demonstrating the final position of the leadless pacemaker in the right ventricular septum.</a:t>
            </a:r>
          </a:p>
        </p:txBody>
      </p:sp>
      <p:sp>
        <p:nvSpPr>
          <p:cNvPr id="12" name="Content Placeholder 4">
            <a:extLst>
              <a:ext uri="{FF2B5EF4-FFF2-40B4-BE49-F238E27FC236}">
                <a16:creationId xmlns:a16="http://schemas.microsoft.com/office/drawing/2014/main" id="{A399265C-47AC-D2EE-794C-CAA0B1B55F57}"/>
              </a:ext>
            </a:extLst>
          </p:cNvPr>
          <p:cNvSpPr txBox="1">
            <a:spLocks/>
          </p:cNvSpPr>
          <p:nvPr/>
        </p:nvSpPr>
        <p:spPr>
          <a:xfrm>
            <a:off x="4886326" y="3914816"/>
            <a:ext cx="3093243" cy="80958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0" dirty="0">
                <a:solidFill>
                  <a:srgbClr val="C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gure 4. </a:t>
            </a:r>
            <a:r>
              <a:rPr lang="en-GB" sz="1000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ectrocardiogram post leadless pacemaker insertion demonstrating atrio-ventricular sequential pacing as the leadless pacemaker was able to track the atrial paced rhythm from a pre-existing device.</a:t>
            </a:r>
          </a:p>
        </p:txBody>
      </p:sp>
    </p:spTree>
    <p:extLst>
      <p:ext uri="{BB962C8B-B14F-4D97-AF65-F5344CB8AC3E}">
        <p14:creationId xmlns:p14="http://schemas.microsoft.com/office/powerpoint/2010/main" val="316174652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7" name="Content Placeholder 4">
            <a:extLst>
              <a:ext uri="{FF2B5EF4-FFF2-40B4-BE49-F238E27FC236}">
                <a16:creationId xmlns:a16="http://schemas.microsoft.com/office/drawing/2014/main" id="{B8D3B6C7-0380-989A-4C1F-9DD7E4F61F33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702640" y="908180"/>
            <a:ext cx="7264689" cy="3342060"/>
          </a:xfrm>
        </p:spPr>
        <p:txBody>
          <a:bodyPr>
            <a:normAutofit/>
          </a:bodyPr>
          <a:lstStyle/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Leadless pacemakers appear to be a viable treatment option for elderly patients with multiple lead failures.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Leadless device implant avoided the need for dual chamber pacemaker implantation with laser lead extraction.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Leadless pacemaker implantation appears to be safe across all patient age groups.[3] Confirmed in the present study.</a:t>
            </a:r>
          </a:p>
        </p:txBody>
      </p:sp>
    </p:spTree>
    <p:extLst>
      <p:ext uri="{BB962C8B-B14F-4D97-AF65-F5344CB8AC3E}">
        <p14:creationId xmlns:p14="http://schemas.microsoft.com/office/powerpoint/2010/main" val="782830419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7" name="Content Placeholder 4">
            <a:extLst>
              <a:ext uri="{FF2B5EF4-FFF2-40B4-BE49-F238E27FC236}">
                <a16:creationId xmlns:a16="http://schemas.microsoft.com/office/drawing/2014/main" id="{B8D3B6C7-0380-989A-4C1F-9DD7E4F61F33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521494" y="714375"/>
            <a:ext cx="7679531" cy="3535865"/>
          </a:xfrm>
        </p:spPr>
        <p:txBody>
          <a:bodyPr>
            <a:noAutofit/>
          </a:bodyPr>
          <a:lstStyle/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Previous ventricular-only devices had indications limited to those with an indication for a VVIR pacemaker or contraindication to transvenous lead.[4]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Accelerometer-based atrial sensing with leadless ventricular pacemakers can enable atrio-ventricular synchrony.[2]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Leadless device tracked the atrial-paced rhythm.</a:t>
            </a:r>
          </a:p>
          <a:p>
            <a:pPr marL="285750" indent="-285750" algn="just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en-GB" b="0" dirty="0"/>
              <a:t>Further studies should examine whether leadless pacemakers could be considered as a first line approach (particularly in cases of lead failure).</a:t>
            </a:r>
          </a:p>
        </p:txBody>
      </p:sp>
    </p:spTree>
    <p:extLst>
      <p:ext uri="{BB962C8B-B14F-4D97-AF65-F5344CB8AC3E}">
        <p14:creationId xmlns:p14="http://schemas.microsoft.com/office/powerpoint/2010/main" val="4290905043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i="0" dirty="0">
                <a:solidFill>
                  <a:srgbClr val="323130"/>
                </a:solidFill>
                <a:effectLst/>
                <a:latin typeface="Segoe UI" panose="020B0502040204020203" pitchFamily="34" charset="0"/>
              </a:rPr>
              <a:t>EHJ-CR-D-22-0045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7" name="Content Placeholder 4">
            <a:extLst>
              <a:ext uri="{FF2B5EF4-FFF2-40B4-BE49-F238E27FC236}">
                <a16:creationId xmlns:a16="http://schemas.microsoft.com/office/drawing/2014/main" id="{B8D3B6C7-0380-989A-4C1F-9DD7E4F61F33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521494" y="971550"/>
            <a:ext cx="7679531" cy="3278690"/>
          </a:xfrm>
        </p:spPr>
        <p:txBody>
          <a:bodyPr>
            <a:noAutofit/>
          </a:bodyPr>
          <a:lstStyle/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GB" sz="2000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pacing-dependent patients who have developed complications associated with conventional lead-based pacemakers, leadless devices present a viable treatment option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GB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Leadless pacemakers can be used with functioning atrial leads from pre-existing devices to achieve atrio-ventricular sequential pacing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GB" b="0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rther studies could examine whether leadless pacemakers could be considered as a first-line approach in elderly patients with multiple comorbidities. This may limit the requirement for repeat procedures and avoid complications associated with conventional devices.</a:t>
            </a:r>
          </a:p>
          <a:p>
            <a:pPr algn="just"/>
            <a:endParaRPr lang="en-GB" b="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GB" b="0" dirty="0">
              <a:latin typeface="+mj-lt"/>
            </a:endParaRPr>
          </a:p>
          <a:p>
            <a:pPr algn="just"/>
            <a:endParaRPr lang="en-GB" sz="2000" b="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GB" sz="2000" b="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792112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9</TotalTime>
  <Words>740</Words>
  <Application>Microsoft Office PowerPoint</Application>
  <PresentationFormat>On-screen Show (16:9)</PresentationFormat>
  <Paragraphs>68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1</vt:i4>
      </vt:variant>
    </vt:vector>
  </HeadingPairs>
  <TitlesOfParts>
    <vt:vector size="19" baseType="lpstr">
      <vt:lpstr>Arial</vt:lpstr>
      <vt:lpstr>Calibri</vt:lpstr>
      <vt:lpstr>Segoe U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Synchronous atrio-ventricular sequential pacing utilising conventional and leadless pacemakers in an elderly patient: a case report </vt:lpstr>
      <vt:lpstr>Introduction</vt:lpstr>
      <vt:lpstr>Case Presentation Presenting complaint</vt:lpstr>
      <vt:lpstr>Case Presentation Investigations</vt:lpstr>
      <vt:lpstr>Case Presentation Management</vt:lpstr>
      <vt:lpstr>Case Presentation Management</vt:lpstr>
      <vt:lpstr>Discussion</vt:lpstr>
      <vt:lpstr>Discussion</vt:lpstr>
      <vt:lpstr>Learning points</vt:lpstr>
      <vt:lpstr>Reference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Neil Bodagh</cp:lastModifiedBy>
  <cp:revision>41</cp:revision>
  <dcterms:created xsi:type="dcterms:W3CDTF">2017-10-02T09:19:02Z</dcterms:created>
  <dcterms:modified xsi:type="dcterms:W3CDTF">2022-10-24T09:0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